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1"/>
  </p:notesMasterIdLst>
  <p:sldIdLst>
    <p:sldId id="264" r:id="rId2"/>
    <p:sldId id="260" r:id="rId3"/>
    <p:sldId id="261" r:id="rId4"/>
    <p:sldId id="262" r:id="rId5"/>
    <p:sldId id="263" r:id="rId6"/>
    <p:sldId id="256" r:id="rId7"/>
    <p:sldId id="257" r:id="rId8"/>
    <p:sldId id="258" r:id="rId9"/>
    <p:sldId id="259" r:id="rId10"/>
  </p:sldIdLst>
  <p:sldSz cx="12192000" cy="6858000"/>
  <p:notesSz cx="6858000" cy="9144000"/>
  <p:defaultTextStyle>
    <a:defPPr>
      <a:defRPr lang="en-T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7"/>
  </p:normalViewPr>
  <p:slideViewPr>
    <p:cSldViewPr snapToGrid="0" snapToObjects="1">
      <p:cViewPr varScale="1">
        <p:scale>
          <a:sx n="107" d="100"/>
          <a:sy n="107" d="100"/>
        </p:scale>
        <p:origin x="736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T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86CAF0-281A-094D-80BA-E8E4455BBB85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T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86D2FD-AB6F-4E4C-9EB9-2FA9437281D3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6840876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T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86D2FD-AB6F-4E4C-9EB9-2FA9437281D3}" type="slidenum">
              <a:rPr lang="en-TH" smtClean="0"/>
              <a:t>5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0197684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1042A6-1F93-6C3A-655F-786624E552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2AABC7-224A-74A5-BA64-5E88364856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81896-5FE5-0790-A523-D86104F579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C83A32-DA2A-A35A-04BB-2515CDA7F7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EF1BDA-F1DC-FF14-BD18-63A1245C24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602057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5448C-4DB3-7A74-0612-F69ABD599E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E59FD0-1AC7-3F9B-1635-AA0481863B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79E1A0-87E4-48CD-2EE7-09E61E98D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ACE6D-DF86-51DC-1F1D-2820FCC7D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2C2346-CCAB-BDD4-63BB-699B2C36A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2077146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54E034-22CB-52CD-30FD-D1EA4C7900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4CD35B-6623-1DEF-597E-2C89AEEB6D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957CC6-70DE-50F0-10CD-2D7B3C0A1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C6126C-955E-40F9-9763-FEDE10644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6A39A7-2C11-B970-31B3-1E16B8A3A0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956888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BD2DB8-10FC-C59C-A29A-39D3AAE947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3C044F-EBC5-7C05-0404-B93276F23AB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AF5A35-9700-D6F8-42A0-84AF8F3D5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46E46F-313F-E80D-3E47-4198E716E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E0EFC1-47D4-D68B-1631-12C8239F89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914431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131908-790B-0021-467E-D107E9F418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872E6B-72EA-94C7-4E20-9055B9E498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9ACE49-81A2-B7AB-792E-91679F1CC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32F275-1EEC-0D2A-4A5F-D009EC8BD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9B2927-3D8F-8CB6-D138-65FD23E1B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3310464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406A1-27DC-1749-281F-8DC9531F2C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9DC2B7-59B3-5FC4-D9B2-476B89B58E1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B8A6FF-483A-0F08-486F-91BED0C164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B60E65-5CF6-5878-3500-1CE26FCDC2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C52793-0EB3-B19D-13E7-56FFB9983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4C96DA-5361-BC7B-54B6-6293320D3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141359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99B3E4-0CEC-34DA-9E91-C5829BBF9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A77F94-4FC4-A3EE-B0A7-F01327D74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3054FD9-8671-D6FD-26C1-3ECB77E5CA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78B926-CE5E-0A4A-28D9-86974781E64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B94E9BF-9541-5939-5F07-B4D5F86AE48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EC62BC8-73C0-B518-C83D-2944DE97D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E73F23-5B8B-639B-B17D-10E203DA7F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6C89F72-DC13-2218-EC7E-7F28A17216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495394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DCD97-BC0B-8FC9-6A50-5CF198F3DE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BB62BCF-B93A-17BF-D7F1-41EED5E1F7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A86697-A910-B12B-FB79-5488BB438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E07B20E-4120-5710-56B4-8763CBFBC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829281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D6293A-DBE8-B9FE-4EC6-7D623E6FB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AD3929-1838-4EAF-22A9-880A36B01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4164146-FAFB-C3D3-0BDF-60C4E9C8B6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01983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A0B27F-34E2-690E-1443-7710DC9FE4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C73049-0F29-BBEE-B535-12460EFDFF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AA851F-4197-8F3E-8016-A906BD5778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03C1CF-EFAE-ADF9-58A8-D1039834CD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A30E7F-BD25-D8B8-7EB6-127EB8EDEA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37FA16-8936-AEF8-FE31-4A5E3F80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1579187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41871-9EDB-A9ED-85C1-8E236BF52E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3D064F-84AF-3221-CC9F-1B9428CB33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T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18F4C5-0FC4-0DDC-06AC-D3C1365757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344058A-2913-D291-486B-9E6ECC5E6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560722-3156-32D6-D6C3-0622B35EA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T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DAC78E-8778-E490-B6AC-EF756D47B7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2832485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F41C56-DEBB-D3FD-4003-82E6E8175F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T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3802FD-0BE9-C583-48C7-20D5CC9A4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T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2C8C6-B4C4-8B80-9115-9477246191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BA305-B97A-7F46-9AD0-F669E209FBE3}" type="datetimeFigureOut">
              <a:rPr lang="en-TH" smtClean="0"/>
              <a:t>23/10/2022 R</a:t>
            </a:fld>
            <a:endParaRPr lang="en-T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0249F8-B104-0210-D12E-8C9FC80628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T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4BF2E6-CCB8-2042-1979-CC2F37EB45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E2844-56C7-074B-80CD-FAEF960B4F67}" type="slidenum">
              <a:rPr lang="en-TH" smtClean="0"/>
              <a:t>‹#›</a:t>
            </a:fld>
            <a:endParaRPr lang="en-TH"/>
          </a:p>
        </p:txBody>
      </p:sp>
    </p:spTree>
    <p:extLst>
      <p:ext uri="{BB962C8B-B14F-4D97-AF65-F5344CB8AC3E}">
        <p14:creationId xmlns:p14="http://schemas.microsoft.com/office/powerpoint/2010/main" val="626617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T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0264AE-A719-A84D-3A65-669393FC13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1557084"/>
            <a:ext cx="12192000" cy="4351338"/>
          </a:xfrm>
        </p:spPr>
        <p:txBody>
          <a:bodyPr>
            <a:normAutofit/>
          </a:bodyPr>
          <a:lstStyle/>
          <a:p>
            <a:pPr marL="0" indent="0" algn="ctr">
              <a:lnSpc>
                <a:spcPct val="200000"/>
              </a:lnSpc>
              <a:buNone/>
            </a:pP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: Figure S2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</a:t>
            </a:r>
          </a:p>
          <a:p>
            <a:pPr marL="0" indent="0" algn="ctr">
              <a:lnSpc>
                <a:spcPct val="200000"/>
              </a:lnSpc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somatic and reproductive tissue samples</a:t>
            </a:r>
          </a:p>
        </p:txBody>
      </p:sp>
    </p:spTree>
    <p:extLst>
      <p:ext uri="{BB962C8B-B14F-4D97-AF65-F5344CB8AC3E}">
        <p14:creationId xmlns:p14="http://schemas.microsoft.com/office/powerpoint/2010/main" val="835300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FC3BD1F-DB57-7986-E52A-D3FBE5923CFF}"/>
              </a:ext>
            </a:extLst>
          </p:cNvPr>
          <p:cNvGrpSpPr/>
          <p:nvPr/>
        </p:nvGrpSpPr>
        <p:grpSpPr>
          <a:xfrm>
            <a:off x="218558" y="1449000"/>
            <a:ext cx="11973442" cy="3960000"/>
            <a:chOff x="218558" y="1449000"/>
            <a:chExt cx="11973442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C2A0F48-6CD6-C4B2-4281-9E872C28303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8558" y="1449000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8EF5F68D-7FD1-F11C-EC74-B552A167923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16000" y="1449000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2EA4D63-A679-EDB8-94B8-23169CDCFFC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32000" y="1449000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5663848C-997D-4A5B-06E2-0596F5A501EB}"/>
              </a:ext>
            </a:extLst>
          </p:cNvPr>
          <p:cNvSpPr txBox="1"/>
          <p:nvPr/>
        </p:nvSpPr>
        <p:spPr>
          <a:xfrm>
            <a:off x="0" y="717325"/>
            <a:ext cx="1219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(the germinal region of the testis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B6D8434-E3DA-57E3-D170-03E026436C14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76427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2092AA9-CE9E-D846-C354-880F952F1902}"/>
              </a:ext>
            </a:extLst>
          </p:cNvPr>
          <p:cNvGrpSpPr/>
          <p:nvPr/>
        </p:nvGrpSpPr>
        <p:grpSpPr>
          <a:xfrm>
            <a:off x="178632" y="1449000"/>
            <a:ext cx="12013368" cy="3960000"/>
            <a:chOff x="178632" y="1449000"/>
            <a:chExt cx="12013368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34C9C0C-D0EB-A2C3-7A3C-266FA5B5936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8632" y="1449000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4097A8C6-3411-81A0-311A-3D9787FD0C2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72000" y="1449000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C4B649D-4C33-F437-85B1-A80A1E97F51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32000" y="1449000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8A02404C-6A4B-EFD5-01CF-2121AA80383E}"/>
              </a:ext>
            </a:extLst>
          </p:cNvPr>
          <p:cNvSpPr txBox="1"/>
          <p:nvPr/>
        </p:nvSpPr>
        <p:spPr>
          <a:xfrm>
            <a:off x="-1" y="612598"/>
            <a:ext cx="12192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Tv tissue samples (testis, part of vas deferens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BF45A140-0A9C-A58B-CDA7-C3A193809AAC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85434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E8E31259-6D92-4261-E774-CE79D8FCF294}"/>
              </a:ext>
            </a:extLst>
          </p:cNvPr>
          <p:cNvGrpSpPr/>
          <p:nvPr/>
        </p:nvGrpSpPr>
        <p:grpSpPr>
          <a:xfrm>
            <a:off x="312000" y="1449000"/>
            <a:ext cx="11880000" cy="3960000"/>
            <a:chOff x="312000" y="1449000"/>
            <a:chExt cx="11880000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A9DB11D-0AD0-48DF-C11B-17C1485E86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2000" y="1449000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16B5E70B-1019-3D5C-FAC3-A42D54B5D16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72000" y="1449000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46C67548-2AF8-8D90-893C-D2C4611E428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32000" y="1449000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9BDF9DAD-C8EB-4F67-795E-C1BA3445F2AA}"/>
              </a:ext>
            </a:extLst>
          </p:cNvPr>
          <p:cNvSpPr txBox="1"/>
          <p:nvPr/>
        </p:nvSpPr>
        <p:spPr>
          <a:xfrm>
            <a:off x="0" y="642578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(seminal vesicle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30A1057-398F-D0CF-D5F5-A40BAC69E419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62958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6F22CC7-6B54-EEBC-6532-FA308DAC205C}"/>
              </a:ext>
            </a:extLst>
          </p:cNvPr>
          <p:cNvGrpSpPr/>
          <p:nvPr/>
        </p:nvGrpSpPr>
        <p:grpSpPr>
          <a:xfrm>
            <a:off x="163643" y="1449000"/>
            <a:ext cx="12028357" cy="3960000"/>
            <a:chOff x="163643" y="1449000"/>
            <a:chExt cx="12028357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59D3CC4-A84B-8FEA-D1D0-FCB89C7F9AB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3643" y="1449000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5557996-F30C-A712-3285-EFF03450BF5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272000" y="1449000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4277B1C-7722-63DC-6630-27985F8EC68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232000" y="1449000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B6A2453A-D82D-3304-B9B8-7AD139046628}"/>
              </a:ext>
            </a:extLst>
          </p:cNvPr>
          <p:cNvSpPr txBox="1"/>
          <p:nvPr/>
        </p:nvSpPr>
        <p:spPr>
          <a:xfrm>
            <a:off x="0" y="67435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(somatic tissue of male worm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8184144-7AEE-2255-B7FA-4AF862BE7F61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testis; Tv: testis, part of vas deferen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eminal vesicle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male somatic tissues.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0328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C5780938-2139-A2B9-D9EC-6A24DBE7AB6F}"/>
              </a:ext>
            </a:extLst>
          </p:cNvPr>
          <p:cNvGrpSpPr/>
          <p:nvPr/>
        </p:nvGrpSpPr>
        <p:grpSpPr>
          <a:xfrm>
            <a:off x="135299" y="1500188"/>
            <a:ext cx="12056701" cy="3960000"/>
            <a:chOff x="135299" y="1500188"/>
            <a:chExt cx="12056701" cy="3960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0B2FA24-B4AC-CCED-F66D-79D180F2DFB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5299" y="1500188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78BA571-92E4-6175-EF79-7A9328D0E5E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95298" y="1500188"/>
              <a:ext cx="3960000" cy="3960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E3B69A2-64BD-6DA5-FDDC-7D2830F1F67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232000" y="1500188"/>
              <a:ext cx="3960000" cy="3960000"/>
            </a:xfrm>
            <a:prstGeom prst="rect">
              <a:avLst/>
            </a:prstGeom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CB42FA83-0FA9-5A14-87B8-8BEEA951904C}"/>
              </a:ext>
            </a:extLst>
          </p:cNvPr>
          <p:cNvSpPr txBox="1"/>
          <p:nvPr/>
        </p:nvSpPr>
        <p:spPr>
          <a:xfrm>
            <a:off x="0" y="751481"/>
            <a:ext cx="121919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(the germinal region of the ovary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B962A6C-B32E-0B0C-1C23-BAC06DACE6EF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942539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62D31D92-71E8-362D-FB94-8AE9F922D7F2}"/>
              </a:ext>
            </a:extLst>
          </p:cNvPr>
          <p:cNvGrpSpPr/>
          <p:nvPr/>
        </p:nvGrpSpPr>
        <p:grpSpPr>
          <a:xfrm>
            <a:off x="280967" y="1449000"/>
            <a:ext cx="11742492" cy="3960000"/>
            <a:chOff x="280967" y="1449000"/>
            <a:chExt cx="11742492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BD196AD-2D9E-776B-9E79-DDFD0383EF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0967" y="1449000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8DA6E4B-F670-F7B9-60D4-EE785EBDD5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40967" y="1449000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7069E07C-00F7-B2DA-CA50-F4090A97510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63459" y="1449000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2AA2B767-D14F-BDF0-287D-BB2FDF916CEE}"/>
              </a:ext>
            </a:extLst>
          </p:cNvPr>
          <p:cNvSpPr txBox="1"/>
          <p:nvPr/>
        </p:nvSpPr>
        <p:spPr>
          <a:xfrm>
            <a:off x="0" y="656769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(ovary, part of oviduct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A61AB2B-23F6-8677-756B-601CCB2832F6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190439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8911643-A280-12AB-44AD-63FB41010871}"/>
              </a:ext>
            </a:extLst>
          </p:cNvPr>
          <p:cNvGrpSpPr/>
          <p:nvPr/>
        </p:nvGrpSpPr>
        <p:grpSpPr>
          <a:xfrm>
            <a:off x="312000" y="1551867"/>
            <a:ext cx="11724000" cy="3960000"/>
            <a:chOff x="312000" y="1633928"/>
            <a:chExt cx="11724000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00B28B83-1B11-3E80-EEAD-11C864B47A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2000" y="1633928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F778DBA4-3561-65D7-EFF3-2357E2DDA97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16000" y="1633928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C8F212A0-0152-BADB-93BC-3E5F1D7B5F0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076000" y="1633928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66A592D9-9B3D-6C2C-2D59-7D0436A97492}"/>
              </a:ext>
            </a:extLst>
          </p:cNvPr>
          <p:cNvSpPr txBox="1"/>
          <p:nvPr/>
        </p:nvSpPr>
        <p:spPr>
          <a:xfrm>
            <a:off x="0" y="675284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Ut tissue samples (uterus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A493232-6789-2D93-5831-051C78110D25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22603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52CC3001-D6BD-EE84-FE00-2641FA208457}"/>
              </a:ext>
            </a:extLst>
          </p:cNvPr>
          <p:cNvGrpSpPr/>
          <p:nvPr/>
        </p:nvGrpSpPr>
        <p:grpSpPr>
          <a:xfrm>
            <a:off x="238594" y="1449000"/>
            <a:ext cx="11880000" cy="3960000"/>
            <a:chOff x="238594" y="1449000"/>
            <a:chExt cx="11880000" cy="396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4BD0BFA-F453-AC6B-CBB2-3D7C7B67D70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8594" y="1449000"/>
              <a:ext cx="3960000" cy="3960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E31B109-EB66-EB93-15F5-ACDB95AE943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98594" y="1449000"/>
              <a:ext cx="3960000" cy="39600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D8B8AC05-1D2D-C283-1183-7EB29E5C74E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158594" y="1449000"/>
              <a:ext cx="3960000" cy="3960000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3F1F3CF0-6FA0-831B-5491-A3051A26F8E7}"/>
              </a:ext>
            </a:extLst>
          </p:cNvPr>
          <p:cNvSpPr txBox="1"/>
          <p:nvPr/>
        </p:nvSpPr>
        <p:spPr>
          <a:xfrm>
            <a:off x="0" y="695942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istribution of reads in different genomic regions of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ssue samples (somatic tissue of female worm)</a:t>
            </a:r>
            <a:endParaRPr lang="en-TH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45085A7-9670-B449-7CA4-99B22907249C}"/>
              </a:ext>
            </a:extLst>
          </p:cNvPr>
          <p:cNvSpPr txBox="1"/>
          <p:nvPr/>
        </p:nvSpPr>
        <p:spPr>
          <a:xfrm>
            <a:off x="858981" y="5524472"/>
            <a:ext cx="107907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 tissue samples include,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g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the germinal zone of the ovary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ary, part of oviduct; Ut: uterus;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f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female somatic tissues. </a:t>
            </a:r>
            <a:endParaRPr lang="en-TH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68461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433</Words>
  <Application>Microsoft Macintosh PowerPoint</Application>
  <PresentationFormat>Widescreen</PresentationFormat>
  <Paragraphs>20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rawan Phuphisut</dc:creator>
  <cp:lastModifiedBy>Orawan Phuphisut</cp:lastModifiedBy>
  <cp:revision>16</cp:revision>
  <dcterms:created xsi:type="dcterms:W3CDTF">2022-04-22T07:16:58Z</dcterms:created>
  <dcterms:modified xsi:type="dcterms:W3CDTF">2022-10-23T02:53:07Z</dcterms:modified>
</cp:coreProperties>
</file>